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5" r:id="rId4"/>
    <p:sldId id="261" r:id="rId5"/>
    <p:sldId id="260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91" autoAdjust="0"/>
    <p:restoredTop sz="94660"/>
  </p:normalViewPr>
  <p:slideViewPr>
    <p:cSldViewPr snapToGrid="0">
      <p:cViewPr varScale="1">
        <p:scale>
          <a:sx n="68" d="100"/>
          <a:sy n="68" d="100"/>
        </p:scale>
        <p:origin x="82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phne.lai\OneDrive%20-%20ubd.edu.bn\Documents\Collaborators\Sokking\Breast%20Cancer%20control%20ANCCA\Draft%209\corr%20tab1&amp;2_29Au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phne.lai\OneDrive%20-%20ubd.edu.bn\Documents\Collaborators\Sokking\Breast%20Cancer%20control%20ANCCA\Draft%209\corr%20tab1&amp;2_29Aug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kking.ong\Documents\Breast%20cancer%20ANCCA\corr%20tab1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kking.ong\Documents\Breast%20cancer%20ANCCA\corr%20tab1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kking.ong\Documents\Breast%20cancer%20ANCCA\corr%20tab1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kking.ong\Documents\Breast%20cancer%20ANCCA\corr%20tab1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cor_Aug14(updated 29Aug)'!$C$102</c:f>
              <c:strCache>
                <c:ptCount val="1"/>
                <c:pt idx="0">
                  <c:v>% of patient diagnosed in stage I, II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4A1D517E-80F8-445B-9EB8-64665A7BD240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2208-4749-AD8A-EB88FBE27B0D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332F08DD-E8ED-44AF-A857-090FB39989C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2208-4749-AD8A-EB88FBE27B0D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30792015-6E4B-499E-A7A3-A611FB25853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2208-4749-AD8A-EB88FBE27B0D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0342C9D0-BEF6-4E3F-B1DE-8DFF8B17FC2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2208-4749-AD8A-EB88FBE27B0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798BF48A-F267-42EA-B57B-667C0163B81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2208-4749-AD8A-EB88FBE27B0D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73BBC317-8CFE-4F70-B3FF-34E01576C1F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2208-4749-AD8A-EB88FBE27B0D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6D79EC31-090A-4779-BB02-5483479BAC67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2208-4749-AD8A-EB88FBE27B0D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C59EB2B4-D163-4B92-B4B8-FE78B67F854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2208-4749-AD8A-EB88FBE27B0D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3B795D44-7CF4-4F6B-956F-2B56BCE5AEC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2208-4749-AD8A-EB88FBE27B0D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3B48DB05-10FF-4AB0-9612-02B45B89F31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2208-4749-AD8A-EB88FBE27B0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8.6142524969613693E-2"/>
                  <c:y val="0.3466848206474190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0.0312x + 59.262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3E-05</a:t>
                    </a:r>
                  </a:p>
                  <a:p>
                    <a:pPr>
                      <a:defRPr/>
                    </a:pPr>
                    <a:r>
                      <a:rPr lang="en-US" sz="1200" dirty="0"/>
                      <a:t>Pearson’s correlation </a:t>
                    </a:r>
                    <a:r>
                      <a:rPr lang="en-US" sz="1200" i="1" dirty="0"/>
                      <a:t>r </a:t>
                    </a:r>
                    <a:r>
                      <a:rPr lang="en-US" sz="1200" dirty="0"/>
                      <a:t>= 0.005 (very weak)</a:t>
                    </a:r>
                  </a:p>
                  <a:p>
                    <a:pPr>
                      <a:defRPr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</a:t>
                    </a:r>
                    <a:r>
                      <a:rPr lang="en-US" sz="1200" dirty="0"/>
                      <a:t> = -0.24 (weak)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cor_Aug14(updated 29Aug)'!$B$103:$B$112</c:f>
              <c:numCache>
                <c:formatCode>General</c:formatCode>
                <c:ptCount val="10"/>
                <c:pt idx="0">
                  <c:v>14</c:v>
                </c:pt>
                <c:pt idx="1">
                  <c:v>6.4</c:v>
                </c:pt>
                <c:pt idx="2">
                  <c:v>11.9</c:v>
                </c:pt>
                <c:pt idx="3">
                  <c:v>8.6</c:v>
                </c:pt>
                <c:pt idx="4">
                  <c:v>5.6</c:v>
                </c:pt>
                <c:pt idx="5">
                  <c:v>5.8</c:v>
                </c:pt>
                <c:pt idx="6">
                  <c:v>7.2</c:v>
                </c:pt>
                <c:pt idx="7">
                  <c:v>12</c:v>
                </c:pt>
                <c:pt idx="8">
                  <c:v>6.4</c:v>
                </c:pt>
                <c:pt idx="9">
                  <c:v>14.6</c:v>
                </c:pt>
              </c:numCache>
            </c:numRef>
          </c:xVal>
          <c:yVal>
            <c:numRef>
              <c:f>'cor_Aug14(updated 29Aug)'!$C$103:$C$112</c:f>
              <c:numCache>
                <c:formatCode>General</c:formatCode>
                <c:ptCount val="10"/>
                <c:pt idx="0">
                  <c:v>40.9</c:v>
                </c:pt>
                <c:pt idx="1">
                  <c:v>73</c:v>
                </c:pt>
                <c:pt idx="2">
                  <c:v>54.2</c:v>
                </c:pt>
                <c:pt idx="3">
                  <c:v>82.1</c:v>
                </c:pt>
                <c:pt idx="4">
                  <c:v>72.2</c:v>
                </c:pt>
                <c:pt idx="5">
                  <c:v>51</c:v>
                </c:pt>
                <c:pt idx="6">
                  <c:v>11</c:v>
                </c:pt>
                <c:pt idx="7">
                  <c:v>76.599999999999994</c:v>
                </c:pt>
                <c:pt idx="8">
                  <c:v>66</c:v>
                </c:pt>
                <c:pt idx="9">
                  <c:v>68.5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cor_Aug14(updated 29Aug)'!$A$103:$A$112</c15:f>
                <c15:dlblRangeCache>
                  <c:ptCount val="10"/>
                  <c:pt idx="0">
                    <c:v>Brunei</c:v>
                  </c:pt>
                  <c:pt idx="1">
                    <c:v>China</c:v>
                  </c:pt>
                  <c:pt idx="2">
                    <c:v>Iran</c:v>
                  </c:pt>
                  <c:pt idx="3">
                    <c:v>Japan</c:v>
                  </c:pt>
                  <c:pt idx="4">
                    <c:v>Korea, Republic</c:v>
                  </c:pt>
                  <c:pt idx="5">
                    <c:v>Mongolia</c:v>
                  </c:pt>
                  <c:pt idx="6">
                    <c:v>Nepal</c:v>
                  </c:pt>
                  <c:pt idx="7">
                    <c:v>Singapore</c:v>
                  </c:pt>
                  <c:pt idx="8">
                    <c:v>Sri Lanka</c:v>
                  </c:pt>
                  <c:pt idx="9">
                    <c:v>Thailand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A-2208-4749-AD8A-EB88FBE27B0D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226856463"/>
        <c:axId val="226862287"/>
      </c:scatterChart>
      <c:valAx>
        <c:axId val="22685646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Age </a:t>
                </a:r>
                <a:r>
                  <a:rPr lang="en-US" sz="1200" dirty="0" err="1"/>
                  <a:t>standardised</a:t>
                </a:r>
                <a:r>
                  <a:rPr lang="en-US" sz="1200" dirty="0"/>
                  <a:t> mortality rate</a:t>
                </a:r>
                <a:r>
                  <a:rPr lang="en-US" sz="1200" baseline="0" dirty="0"/>
                  <a:t> of breast cancer per 100,000 female population from national or local cancer registry</a:t>
                </a:r>
                <a:endParaRPr lang="en-US" sz="12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862287"/>
        <c:crosses val="autoZero"/>
        <c:crossBetween val="midCat"/>
      </c:valAx>
      <c:valAx>
        <c:axId val="2268622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Percentage of patient diagnosed in stage I, II</a:t>
                </a:r>
              </a:p>
            </c:rich>
          </c:tx>
          <c:layout>
            <c:manualLayout>
              <c:xMode val="edge"/>
              <c:yMode val="edge"/>
              <c:x val="1.2906547786408491E-2"/>
              <c:y val="0.274328689683020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85646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cor_Aug14(updated 29Aug)'!$C$80</c:f>
              <c:strCache>
                <c:ptCount val="1"/>
                <c:pt idx="0">
                  <c:v>% of patient diagnosed in stage I, II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1126584D-B253-4A41-8B90-8CBF5EE3C30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F8AF-4F1F-B9E4-DCB31849D3F9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F20F9DA1-23EA-4945-A414-573AAADDC35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F8AF-4F1F-B9E4-DCB31849D3F9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F337B216-5057-4C00-A813-A0467A9F496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F8AF-4F1F-B9E4-DCB31849D3F9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A38C4C7-2EBB-4759-B02F-422D932C5AF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F8AF-4F1F-B9E4-DCB31849D3F9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A781FA58-D035-4B32-B42E-CC36D4F81A3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F8AF-4F1F-B9E4-DCB31849D3F9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086B5016-F48F-4107-AB40-F8C720C6E4D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F8AF-4F1F-B9E4-DCB31849D3F9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B88E5C84-9A27-450E-AD80-4C5A271208B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F8AF-4F1F-B9E4-DCB31849D3F9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890D6AD2-F2E3-49FC-83EC-DAFFF9B5F7B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F8AF-4F1F-B9E4-DCB31849D3F9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8119AB49-FDCA-4F76-8D2D-E51EDE0B0C3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F8AF-4F1F-B9E4-DCB31849D3F9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03261555-4706-434F-A524-9788537C117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F8AF-4F1F-B9E4-DCB31849D3F9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267F587F-9CAA-46BA-B0BA-B24AFE4ABC75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F8AF-4F1F-B9E4-DCB31849D3F9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CD0FB5EF-8560-40E9-98E4-F4E127C2B49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F8AF-4F1F-B9E4-DCB31849D3F9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88413200-96E3-42F4-830B-1C7620D2E04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C-F8AF-4F1F-B9E4-DCB31849D3F9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DFC55979-284C-480F-B554-37F320961B1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D-F8AF-4F1F-B9E4-DCB31849D3F9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B6182E95-F3CF-4B15-A6D6-1B039087E19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E-F8AF-4F1F-B9E4-DCB31849D3F9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D46CAAE0-D59B-4700-987B-E26F16403D6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F-F8AF-4F1F-B9E4-DCB31849D3F9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FF239122-2E6B-4387-B42D-98A1B646D5B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0-F8AF-4F1F-B9E4-DCB31849D3F9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FBCE5A2A-5BD6-4352-897D-B758C2F5835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1-F8AF-4F1F-B9E4-DCB31849D3F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9.5771412194165378E-2"/>
                  <c:y val="0.2695332458442694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0.535x + 43.04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0.0117</a:t>
                    </a:r>
                  </a:p>
                  <a:p>
                    <a:pPr>
                      <a:defRPr sz="1200"/>
                    </a:pPr>
                    <a:r>
                      <a:rPr lang="en-US" sz="1200" b="0" i="0" u="none" strike="noStrike" baseline="0" dirty="0">
                        <a:effectLst/>
                      </a:rPr>
                      <a:t>Pearson’s correlation </a:t>
                    </a:r>
                    <a:r>
                      <a:rPr lang="en-US" sz="1200" b="0" i="1" u="none" strike="noStrike" baseline="0" dirty="0">
                        <a:effectLst/>
                      </a:rPr>
                      <a:t>r </a:t>
                    </a:r>
                    <a:r>
                      <a:rPr lang="en-US" sz="1200" b="0" i="0" u="none" strike="noStrike" baseline="0" dirty="0">
                        <a:effectLst/>
                      </a:rPr>
                      <a:t>= 0.11 (very weak)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</a:t>
                    </a:r>
                    <a:r>
                      <a:rPr lang="en-US" sz="1200" dirty="0"/>
                      <a:t> = 0.41 (moderate)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cor_Aug14(updated 29Aug)'!$B$81:$B$98</c:f>
              <c:numCache>
                <c:formatCode>General</c:formatCode>
                <c:ptCount val="18"/>
                <c:pt idx="0">
                  <c:v>9.3000000000000007</c:v>
                </c:pt>
                <c:pt idx="1">
                  <c:v>12.5</c:v>
                </c:pt>
                <c:pt idx="2">
                  <c:v>10.3</c:v>
                </c:pt>
                <c:pt idx="3">
                  <c:v>10</c:v>
                </c:pt>
                <c:pt idx="4">
                  <c:v>13.3</c:v>
                </c:pt>
                <c:pt idx="5">
                  <c:v>10.8</c:v>
                </c:pt>
                <c:pt idx="6">
                  <c:v>9.9</c:v>
                </c:pt>
                <c:pt idx="7">
                  <c:v>6.4</c:v>
                </c:pt>
                <c:pt idx="8">
                  <c:v>15.8</c:v>
                </c:pt>
                <c:pt idx="9">
                  <c:v>20.7</c:v>
                </c:pt>
                <c:pt idx="10">
                  <c:v>3.9</c:v>
                </c:pt>
                <c:pt idx="11">
                  <c:v>7.6</c:v>
                </c:pt>
                <c:pt idx="12">
                  <c:v>18.8</c:v>
                </c:pt>
                <c:pt idx="13">
                  <c:v>19.3</c:v>
                </c:pt>
                <c:pt idx="14">
                  <c:v>17.8</c:v>
                </c:pt>
                <c:pt idx="15">
                  <c:v>11</c:v>
                </c:pt>
                <c:pt idx="16">
                  <c:v>12.7</c:v>
                </c:pt>
                <c:pt idx="17">
                  <c:v>13.8</c:v>
                </c:pt>
              </c:numCache>
            </c:numRef>
          </c:xVal>
          <c:yVal>
            <c:numRef>
              <c:f>'cor_Aug14(updated 29Aug)'!$C$81:$C$98</c:f>
              <c:numCache>
                <c:formatCode>General</c:formatCode>
                <c:ptCount val="18"/>
                <c:pt idx="0">
                  <c:v>4</c:v>
                </c:pt>
                <c:pt idx="1">
                  <c:v>40.9</c:v>
                </c:pt>
                <c:pt idx="2">
                  <c:v>22.2</c:v>
                </c:pt>
                <c:pt idx="3">
                  <c:v>73</c:v>
                </c:pt>
                <c:pt idx="4">
                  <c:v>29</c:v>
                </c:pt>
                <c:pt idx="5">
                  <c:v>54.2</c:v>
                </c:pt>
                <c:pt idx="6">
                  <c:v>82.1</c:v>
                </c:pt>
                <c:pt idx="7">
                  <c:v>72.2</c:v>
                </c:pt>
                <c:pt idx="8">
                  <c:v>67</c:v>
                </c:pt>
                <c:pt idx="9">
                  <c:v>52</c:v>
                </c:pt>
                <c:pt idx="10">
                  <c:v>51</c:v>
                </c:pt>
                <c:pt idx="11">
                  <c:v>11</c:v>
                </c:pt>
                <c:pt idx="12">
                  <c:v>42</c:v>
                </c:pt>
                <c:pt idx="13">
                  <c:v>47</c:v>
                </c:pt>
                <c:pt idx="14">
                  <c:v>76.599999999999994</c:v>
                </c:pt>
                <c:pt idx="15">
                  <c:v>66</c:v>
                </c:pt>
                <c:pt idx="16">
                  <c:v>68.5</c:v>
                </c:pt>
                <c:pt idx="17">
                  <c:v>35.799999999999997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cor_Aug14(updated 29Aug)'!$A$81:$A$98</c15:f>
                <c15:dlblRangeCache>
                  <c:ptCount val="18"/>
                  <c:pt idx="0">
                    <c:v>Bangladesh</c:v>
                  </c:pt>
                  <c:pt idx="1">
                    <c:v>Brunei</c:v>
                  </c:pt>
                  <c:pt idx="2">
                    <c:v>Cambodia</c:v>
                  </c:pt>
                  <c:pt idx="3">
                    <c:v>China</c:v>
                  </c:pt>
                  <c:pt idx="4">
                    <c:v>India</c:v>
                  </c:pt>
                  <c:pt idx="5">
                    <c:v>Iran</c:v>
                  </c:pt>
                  <c:pt idx="6">
                    <c:v>Japan</c:v>
                  </c:pt>
                  <c:pt idx="7">
                    <c:v>Korea, Republic</c:v>
                  </c:pt>
                  <c:pt idx="8">
                    <c:v>Lao PDR</c:v>
                  </c:pt>
                  <c:pt idx="9">
                    <c:v>Malaysia</c:v>
                  </c:pt>
                  <c:pt idx="10">
                    <c:v>Mongolia</c:v>
                  </c:pt>
                  <c:pt idx="11">
                    <c:v>Nepal</c:v>
                  </c:pt>
                  <c:pt idx="12">
                    <c:v>Pakistan</c:v>
                  </c:pt>
                  <c:pt idx="13">
                    <c:v>Philippines</c:v>
                  </c:pt>
                  <c:pt idx="14">
                    <c:v>Singapore</c:v>
                  </c:pt>
                  <c:pt idx="15">
                    <c:v>Sri Lanka</c:v>
                  </c:pt>
                  <c:pt idx="16">
                    <c:v>Thailand</c:v>
                  </c:pt>
                  <c:pt idx="17">
                    <c:v>Vietnam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2-F8AF-4F1F-B9E4-DCB31849D3F9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227777647"/>
        <c:axId val="227776399"/>
      </c:scatterChart>
      <c:valAx>
        <c:axId val="22777764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Age </a:t>
                </a:r>
                <a:r>
                  <a:rPr lang="en-US" sz="1200" dirty="0" err="1"/>
                  <a:t>standardised</a:t>
                </a:r>
                <a:r>
                  <a:rPr lang="en-US" sz="1200" dirty="0"/>
                  <a:t> mortality ate (ASMR) of breast cancer per 100,000 female population, GLOBOCAN 2020 estimates</a:t>
                </a:r>
              </a:p>
            </c:rich>
          </c:tx>
          <c:layout>
            <c:manualLayout>
              <c:xMode val="edge"/>
              <c:yMode val="edge"/>
              <c:x val="0.13938922422495598"/>
              <c:y val="0.916025641025640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776399"/>
        <c:crosses val="autoZero"/>
        <c:crossBetween val="midCat"/>
      </c:valAx>
      <c:valAx>
        <c:axId val="2277763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Percentage of patient diagnosed in stage I, I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77764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481304932676866E-2"/>
          <c:y val="8.8285244938526505E-2"/>
          <c:w val="0.90939391692550997"/>
          <c:h val="0.81216898612406074"/>
        </c:manualLayout>
      </c:layout>
      <c:scatterChart>
        <c:scatterStyle val="lineMarker"/>
        <c:varyColors val="0"/>
        <c:ser>
          <c:idx val="0"/>
          <c:order val="0"/>
          <c:tx>
            <c:strRef>
              <c:f>cor_Aug15!$D$27</c:f>
              <c:strCache>
                <c:ptCount val="1"/>
                <c:pt idx="0">
                  <c:v>% 5-year survival 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A750C30F-8E8E-411B-8411-7A94B64D79F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279D-4A1E-AA9D-35732E7087F0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06983517-A748-4B97-B440-EFE0EB018470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279D-4A1E-AA9D-35732E7087F0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6498BCBF-1C94-424D-9848-A221ACA543C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279D-4A1E-AA9D-35732E7087F0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CF88947-A8B7-4714-8856-812A1C2DAD5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279D-4A1E-AA9D-35732E7087F0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D94E4677-0555-4B27-87CC-AEEFCB29603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279D-4A1E-AA9D-35732E7087F0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5C7531D6-1AF6-4E52-9708-02143B46EFA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279D-4A1E-AA9D-35732E7087F0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F6AF8F02-C4DF-44FC-B096-1EF49F4ED12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279D-4A1E-AA9D-35732E7087F0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B26634BF-3075-4792-85D4-2C64F1C677B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279D-4A1E-AA9D-35732E7087F0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7F6ED6F5-9924-42B7-B824-0DE23CD5D36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279D-4A1E-AA9D-35732E7087F0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50C9D105-02C4-4513-B2CF-A28B6FA69E1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279D-4A1E-AA9D-35732E7087F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6.4990283106423257E-3"/>
                  <c:y val="0.2882120214807822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-1.0712x + 89.407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0.2202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Pearson’s correlation </a:t>
                    </a:r>
                    <a:r>
                      <a:rPr lang="en-US" sz="1200" i="1" dirty="0"/>
                      <a:t>r </a:t>
                    </a:r>
                    <a:r>
                      <a:rPr lang="en-US" sz="1200" dirty="0"/>
                      <a:t>= -0.47 (moderate)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</a:t>
                    </a:r>
                    <a:r>
                      <a:rPr lang="en-US" sz="1200" dirty="0"/>
                      <a:t> = -0.54 (moderate)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cor_Aug15!$C$28:$C$37</c:f>
              <c:numCache>
                <c:formatCode>General</c:formatCode>
                <c:ptCount val="10"/>
                <c:pt idx="0">
                  <c:v>14</c:v>
                </c:pt>
                <c:pt idx="1">
                  <c:v>6.4</c:v>
                </c:pt>
                <c:pt idx="2">
                  <c:v>15.4</c:v>
                </c:pt>
                <c:pt idx="3">
                  <c:v>11.9</c:v>
                </c:pt>
                <c:pt idx="4">
                  <c:v>8.6</c:v>
                </c:pt>
                <c:pt idx="5">
                  <c:v>5.6</c:v>
                </c:pt>
                <c:pt idx="6">
                  <c:v>5.8</c:v>
                </c:pt>
                <c:pt idx="7">
                  <c:v>12</c:v>
                </c:pt>
                <c:pt idx="8">
                  <c:v>6.4</c:v>
                </c:pt>
                <c:pt idx="9">
                  <c:v>14.6</c:v>
                </c:pt>
              </c:numCache>
            </c:numRef>
          </c:xVal>
          <c:yVal>
            <c:numRef>
              <c:f>cor_Aug15!$D$28:$D$37</c:f>
              <c:numCache>
                <c:formatCode>General</c:formatCode>
                <c:ptCount val="10"/>
                <c:pt idx="0">
                  <c:v>72</c:v>
                </c:pt>
                <c:pt idx="1">
                  <c:v>82</c:v>
                </c:pt>
                <c:pt idx="2">
                  <c:v>77.7</c:v>
                </c:pt>
                <c:pt idx="3">
                  <c:v>69.5</c:v>
                </c:pt>
                <c:pt idx="4">
                  <c:v>92.3</c:v>
                </c:pt>
                <c:pt idx="5">
                  <c:v>93.8</c:v>
                </c:pt>
                <c:pt idx="6">
                  <c:v>76.099999999999994</c:v>
                </c:pt>
                <c:pt idx="7">
                  <c:v>82.4</c:v>
                </c:pt>
                <c:pt idx="8">
                  <c:v>71.599999999999994</c:v>
                </c:pt>
                <c:pt idx="9">
                  <c:v>68.8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cor_Aug15!$B$28:$B$37</c15:f>
                <c15:dlblRangeCache>
                  <c:ptCount val="10"/>
                  <c:pt idx="0">
                    <c:v>Brunei</c:v>
                  </c:pt>
                  <c:pt idx="1">
                    <c:v>China</c:v>
                  </c:pt>
                  <c:pt idx="2">
                    <c:v>Indonesia</c:v>
                  </c:pt>
                  <c:pt idx="3">
                    <c:v>Iran</c:v>
                  </c:pt>
                  <c:pt idx="4">
                    <c:v>Japan</c:v>
                  </c:pt>
                  <c:pt idx="5">
                    <c:v>Korea, Republic</c:v>
                  </c:pt>
                  <c:pt idx="6">
                    <c:v>Mongolia</c:v>
                  </c:pt>
                  <c:pt idx="7">
                    <c:v>Singapore</c:v>
                  </c:pt>
                  <c:pt idx="8">
                    <c:v>Sri Lanka</c:v>
                  </c:pt>
                  <c:pt idx="9">
                    <c:v>Thailand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C-279D-4A1E-AA9D-35732E7087F0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146411919"/>
        <c:axId val="146422319"/>
      </c:scatterChart>
      <c:valAx>
        <c:axId val="14641191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Age </a:t>
                </a:r>
                <a:r>
                  <a:rPr lang="en-US" sz="1200" dirty="0" err="1"/>
                  <a:t>standardised</a:t>
                </a:r>
                <a:r>
                  <a:rPr lang="en-US" sz="1200" baseline="0" dirty="0"/>
                  <a:t> m</a:t>
                </a:r>
                <a:r>
                  <a:rPr lang="en-US" sz="1200" dirty="0"/>
                  <a:t>ortality rate of breast cancer per 100,000 female population</a:t>
                </a:r>
                <a:r>
                  <a:rPr lang="en-US" sz="1200" baseline="0" dirty="0"/>
                  <a:t> from the national or l</a:t>
                </a:r>
                <a:r>
                  <a:rPr lang="en-US" sz="1200" dirty="0"/>
                  <a:t>ocal cancer</a:t>
                </a:r>
                <a:r>
                  <a:rPr lang="en-US" sz="1200" baseline="0" dirty="0"/>
                  <a:t> r</a:t>
                </a:r>
                <a:r>
                  <a:rPr lang="en-US" sz="1200" dirty="0"/>
                  <a:t>egistry</a:t>
                </a:r>
              </a:p>
            </c:rich>
          </c:tx>
          <c:layout>
            <c:manualLayout>
              <c:xMode val="edge"/>
              <c:yMode val="edge"/>
              <c:x val="0.34546257009571973"/>
              <c:y val="0.961135825560570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422319"/>
        <c:crosses val="autoZero"/>
        <c:crossBetween val="midCat"/>
      </c:valAx>
      <c:valAx>
        <c:axId val="1464223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Percentage</a:t>
                </a:r>
                <a:r>
                  <a:rPr lang="en-US" sz="1200" baseline="0" dirty="0"/>
                  <a:t> of patients with</a:t>
                </a:r>
                <a:r>
                  <a:rPr lang="en-US" sz="1200" dirty="0"/>
                  <a:t> 5-year survival </a:t>
                </a:r>
              </a:p>
            </c:rich>
          </c:tx>
          <c:layout>
            <c:manualLayout>
              <c:xMode val="edge"/>
              <c:yMode val="edge"/>
              <c:x val="1.3167096445592767E-2"/>
              <c:y val="0.329228209069727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41191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r_Aug14!$C$57</c:f>
              <c:strCache>
                <c:ptCount val="1"/>
                <c:pt idx="0">
                  <c:v>UHC index (0-100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C4511793-64A3-4411-8A51-A0605567B74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4520-493B-A2B2-85AE84FE4B00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308498EF-B21F-44E7-B307-16FB2E807B70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4520-493B-A2B2-85AE84FE4B00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F7161EC9-D9DC-433D-B857-75E403946C0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4520-493B-A2B2-85AE84FE4B00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0A4F716B-B10A-43AF-9E30-A642D8D2F7F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4520-493B-A2B2-85AE84FE4B00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7AEBAD71-066E-4745-93E5-B4BA3C028B8A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4520-493B-A2B2-85AE84FE4B00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7A045282-F2CE-42A9-901E-E5575A19004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4520-493B-A2B2-85AE84FE4B00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0ADD57E6-7CAD-4C91-A261-97B80AC812A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4520-493B-A2B2-85AE84FE4B00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9563EAB6-2C22-486E-8386-9C11265E021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4520-493B-A2B2-85AE84FE4B00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39798E61-A65F-4C0B-A18B-AECB3523272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4520-493B-A2B2-85AE84FE4B00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D49EF91A-38C6-46A7-B6A3-0D3259F406E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4520-493B-A2B2-85AE84FE4B00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AEFCF2F8-33F0-44FA-B74B-69738B77BFD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4520-493B-A2B2-85AE84FE4B00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189D435F-9D54-42E8-B714-0E0227BB3CD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4520-493B-A2B2-85AE84FE4B0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0208668690239925E-2"/>
                  <c:y val="0.3141552118314540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-0.3294x + 76.786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0.014</a:t>
                    </a:r>
                  </a:p>
                  <a:p>
                    <a:pPr>
                      <a:defRPr sz="1200"/>
                    </a:pPr>
                    <a:r>
                      <a:rPr lang="en-US" sz="1200" b="0" i="0" u="none" strike="noStrike" baseline="0" dirty="0">
                        <a:effectLst/>
                      </a:rPr>
                      <a:t>Pearson’s correlation </a:t>
                    </a:r>
                    <a:r>
                      <a:rPr lang="en-US" sz="1200" b="0" i="1" u="none" strike="noStrike" baseline="0" dirty="0">
                        <a:effectLst/>
                      </a:rPr>
                      <a:t>r </a:t>
                    </a:r>
                    <a:r>
                      <a:rPr lang="en-US" sz="1200" b="0" i="0" u="none" strike="noStrike" baseline="0" dirty="0">
                        <a:effectLst/>
                      </a:rPr>
                      <a:t>= -0.12 (very weak)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</a:t>
                    </a:r>
                    <a:r>
                      <a:rPr lang="en-US" sz="1200" dirty="0"/>
                      <a:t> = -0.77 (strong)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cor_Aug14!$B$58:$B$69</c:f>
              <c:numCache>
                <c:formatCode>General</c:formatCode>
                <c:ptCount val="12"/>
                <c:pt idx="0">
                  <c:v>14</c:v>
                </c:pt>
                <c:pt idx="1">
                  <c:v>6.4</c:v>
                </c:pt>
                <c:pt idx="2">
                  <c:v>15.4</c:v>
                </c:pt>
                <c:pt idx="3">
                  <c:v>11.9</c:v>
                </c:pt>
                <c:pt idx="4">
                  <c:v>8.6</c:v>
                </c:pt>
                <c:pt idx="5">
                  <c:v>5.6</c:v>
                </c:pt>
                <c:pt idx="6">
                  <c:v>5.8</c:v>
                </c:pt>
                <c:pt idx="7">
                  <c:v>17.899999999999999</c:v>
                </c:pt>
                <c:pt idx="8">
                  <c:v>7.2</c:v>
                </c:pt>
                <c:pt idx="9">
                  <c:v>12</c:v>
                </c:pt>
                <c:pt idx="10">
                  <c:v>6.4</c:v>
                </c:pt>
                <c:pt idx="11">
                  <c:v>14.6</c:v>
                </c:pt>
              </c:numCache>
            </c:numRef>
          </c:xVal>
          <c:yVal>
            <c:numRef>
              <c:f>cor_Aug14!$C$58:$C$69</c:f>
              <c:numCache>
                <c:formatCode>General</c:formatCode>
                <c:ptCount val="12"/>
                <c:pt idx="0">
                  <c:v>77</c:v>
                </c:pt>
                <c:pt idx="1">
                  <c:v>82</c:v>
                </c:pt>
                <c:pt idx="2">
                  <c:v>59</c:v>
                </c:pt>
                <c:pt idx="3">
                  <c:v>77</c:v>
                </c:pt>
                <c:pt idx="4">
                  <c:v>85</c:v>
                </c:pt>
                <c:pt idx="5">
                  <c:v>87</c:v>
                </c:pt>
                <c:pt idx="6">
                  <c:v>63</c:v>
                </c:pt>
                <c:pt idx="7">
                  <c:v>61</c:v>
                </c:pt>
                <c:pt idx="8">
                  <c:v>53</c:v>
                </c:pt>
                <c:pt idx="9">
                  <c:v>86</c:v>
                </c:pt>
                <c:pt idx="10">
                  <c:v>67</c:v>
                </c:pt>
                <c:pt idx="11">
                  <c:v>83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cor_Aug14!$A$58:$A$69</c15:f>
                <c15:dlblRangeCache>
                  <c:ptCount val="12"/>
                  <c:pt idx="0">
                    <c:v>Brunei</c:v>
                  </c:pt>
                  <c:pt idx="1">
                    <c:v>China</c:v>
                  </c:pt>
                  <c:pt idx="2">
                    <c:v>Indonesia</c:v>
                  </c:pt>
                  <c:pt idx="3">
                    <c:v>Iran</c:v>
                  </c:pt>
                  <c:pt idx="4">
                    <c:v>Japan</c:v>
                  </c:pt>
                  <c:pt idx="5">
                    <c:v>Korea, Republic</c:v>
                  </c:pt>
                  <c:pt idx="6">
                    <c:v>Mongolia</c:v>
                  </c:pt>
                  <c:pt idx="7">
                    <c:v>Myanmar</c:v>
                  </c:pt>
                  <c:pt idx="8">
                    <c:v>Nepal</c:v>
                  </c:pt>
                  <c:pt idx="9">
                    <c:v>Singapore</c:v>
                  </c:pt>
                  <c:pt idx="10">
                    <c:v>Sri Lanka</c:v>
                  </c:pt>
                  <c:pt idx="11">
                    <c:v>Thailand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E-4520-493B-A2B2-85AE84FE4B00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228164367"/>
        <c:axId val="228165199"/>
      </c:scatterChart>
      <c:valAx>
        <c:axId val="22816436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Age </a:t>
                </a:r>
                <a:r>
                  <a:rPr lang="en-US" sz="1200" b="0" i="0" kern="1200" baseline="0" dirty="0" err="1">
                    <a:solidFill>
                      <a:srgbClr val="595959"/>
                    </a:solidFill>
                    <a:effectLst/>
                  </a:rPr>
                  <a:t>standardised</a:t>
                </a: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 mortality rate of breast cancer per 100,000 female population from the national or local cancer registry</a:t>
                </a:r>
                <a:endParaRPr lang="en-US" sz="12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8165199"/>
        <c:crosses val="autoZero"/>
        <c:crossBetween val="midCat"/>
      </c:valAx>
      <c:valAx>
        <c:axId val="2281651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Universal</a:t>
                </a:r>
                <a:r>
                  <a:rPr lang="en-US" sz="1200" baseline="0" dirty="0"/>
                  <a:t> Health Coverage</a:t>
                </a:r>
                <a:r>
                  <a:rPr lang="en-US" sz="1200" dirty="0"/>
                  <a:t> index (0-100)
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81643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r_Aug14!$C$31</c:f>
              <c:strCache>
                <c:ptCount val="1"/>
                <c:pt idx="0">
                  <c:v>UHC index (0-100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C2D11636-CB40-48B9-B1CF-67A106AEF30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22AC-4DE8-A436-E77489AD0F7F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D5021C62-F797-4D45-9C01-54745C0EDFF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22AC-4DE8-A436-E77489AD0F7F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62A59F1F-5CCC-42EF-B1C9-354FF49BDD6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22AC-4DE8-A436-E77489AD0F7F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6C3DAD70-4310-42D6-A135-5BAE438A26E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22AC-4DE8-A436-E77489AD0F7F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D0FD2AE2-C9DB-444B-81C3-714C1721294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22AC-4DE8-A436-E77489AD0F7F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1C388108-53CA-4ECF-B93E-041BF28868B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22AC-4DE8-A436-E77489AD0F7F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CB36F0AA-DCB9-42EB-B783-8920C0F0F29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22AC-4DE8-A436-E77489AD0F7F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DC09350D-C13C-4F56-B18B-D8FE625E7B0A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22AC-4DE8-A436-E77489AD0F7F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56032014-0E6A-4BBC-8868-659AAD432DE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22AC-4DE8-A436-E77489AD0F7F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515FA7D6-FF26-4B22-9FCD-CE30D6276FA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22AC-4DE8-A436-E77489AD0F7F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DD822A14-7013-4AC3-ABB0-1C08E7A47979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22AC-4DE8-A436-E77489AD0F7F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302667A4-47AA-49E0-BF94-AAFD604C926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22AC-4DE8-A436-E77489AD0F7F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7EF3F493-3AF0-4EA2-87E1-853431F77135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C-22AC-4DE8-A436-E77489AD0F7F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59160902-D0A2-4E99-BE5B-52F09107DF9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D-22AC-4DE8-A436-E77489AD0F7F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A17B44CA-3B73-4FCF-8FDE-083494D0B523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E-22AC-4DE8-A436-E77489AD0F7F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E4D76902-4AE2-4E9E-8792-9524BD8B302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F-22AC-4DE8-A436-E77489AD0F7F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C797E1DE-C8DE-448A-BDF5-8F4F89D9757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0-22AC-4DE8-A436-E77489AD0F7F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A71D2722-C35F-4496-B0F4-30B2A650538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1-22AC-4DE8-A436-E77489AD0F7F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fld id="{E4F25C17-C73F-4C49-892E-9ED4567B8CF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2-22AC-4DE8-A436-E77489AD0F7F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fld id="{11111A6B-D334-476B-A1C4-2BC7E07E2AF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3-22AC-4DE8-A436-E77489AD0F7F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fld id="{FB4685F4-C143-4844-A0B2-B41B917CB92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4-22AC-4DE8-A436-E77489AD0F7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2616135916409185"/>
                  <c:y val="0.358479101226005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-0.2308x + 69.954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0.0073</a:t>
                    </a:r>
                  </a:p>
                  <a:p>
                    <a:pPr>
                      <a:defRPr sz="1200"/>
                    </a:pPr>
                    <a:r>
                      <a:rPr lang="en-US" sz="1200" b="0" i="0" u="none" strike="noStrike" baseline="0" dirty="0">
                        <a:effectLst/>
                      </a:rPr>
                      <a:t>Pearson’s correlation </a:t>
                    </a:r>
                    <a:r>
                      <a:rPr lang="en-US" sz="1200" b="0" i="1" u="none" strike="noStrike" baseline="0" dirty="0">
                        <a:effectLst/>
                      </a:rPr>
                      <a:t>r </a:t>
                    </a:r>
                    <a:r>
                      <a:rPr lang="en-US" sz="1200" b="0" i="0" u="none" strike="noStrike" baseline="0" dirty="0">
                        <a:effectLst/>
                      </a:rPr>
                      <a:t>= -0.09 (very weak)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</a:t>
                    </a:r>
                    <a:r>
                      <a:rPr lang="en-US" sz="1200" dirty="0"/>
                      <a:t> = -0.67 (strong)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cor_Aug14!$B$32:$B$52</c:f>
              <c:numCache>
                <c:formatCode>General</c:formatCode>
                <c:ptCount val="21"/>
                <c:pt idx="0">
                  <c:v>9.3000000000000007</c:v>
                </c:pt>
                <c:pt idx="1">
                  <c:v>2.6</c:v>
                </c:pt>
                <c:pt idx="2">
                  <c:v>12.5</c:v>
                </c:pt>
                <c:pt idx="3">
                  <c:v>10.3</c:v>
                </c:pt>
                <c:pt idx="4">
                  <c:v>10</c:v>
                </c:pt>
                <c:pt idx="5">
                  <c:v>13.3</c:v>
                </c:pt>
                <c:pt idx="6">
                  <c:v>15.3</c:v>
                </c:pt>
                <c:pt idx="7">
                  <c:v>10.8</c:v>
                </c:pt>
                <c:pt idx="8">
                  <c:v>9.9</c:v>
                </c:pt>
                <c:pt idx="9">
                  <c:v>6.4</c:v>
                </c:pt>
                <c:pt idx="10">
                  <c:v>15.8</c:v>
                </c:pt>
                <c:pt idx="11">
                  <c:v>20.7</c:v>
                </c:pt>
                <c:pt idx="12">
                  <c:v>3.9</c:v>
                </c:pt>
                <c:pt idx="13">
                  <c:v>9.6</c:v>
                </c:pt>
                <c:pt idx="14">
                  <c:v>7.6</c:v>
                </c:pt>
                <c:pt idx="15">
                  <c:v>18.8</c:v>
                </c:pt>
                <c:pt idx="16">
                  <c:v>19.3</c:v>
                </c:pt>
                <c:pt idx="17">
                  <c:v>17.8</c:v>
                </c:pt>
                <c:pt idx="18">
                  <c:v>11</c:v>
                </c:pt>
                <c:pt idx="19">
                  <c:v>12.7</c:v>
                </c:pt>
                <c:pt idx="20">
                  <c:v>13.8</c:v>
                </c:pt>
              </c:numCache>
            </c:numRef>
          </c:xVal>
          <c:yVal>
            <c:numRef>
              <c:f>cor_Aug14!$C$32:$C$52</c:f>
              <c:numCache>
                <c:formatCode>General</c:formatCode>
                <c:ptCount val="21"/>
                <c:pt idx="0">
                  <c:v>51</c:v>
                </c:pt>
                <c:pt idx="1">
                  <c:v>62</c:v>
                </c:pt>
                <c:pt idx="2">
                  <c:v>77</c:v>
                </c:pt>
                <c:pt idx="3">
                  <c:v>61</c:v>
                </c:pt>
                <c:pt idx="4">
                  <c:v>82</c:v>
                </c:pt>
                <c:pt idx="5">
                  <c:v>61</c:v>
                </c:pt>
                <c:pt idx="6">
                  <c:v>59</c:v>
                </c:pt>
                <c:pt idx="7">
                  <c:v>77</c:v>
                </c:pt>
                <c:pt idx="8">
                  <c:v>85</c:v>
                </c:pt>
                <c:pt idx="9">
                  <c:v>87</c:v>
                </c:pt>
                <c:pt idx="10">
                  <c:v>50</c:v>
                </c:pt>
                <c:pt idx="11">
                  <c:v>76</c:v>
                </c:pt>
                <c:pt idx="12">
                  <c:v>63</c:v>
                </c:pt>
                <c:pt idx="13">
                  <c:v>61</c:v>
                </c:pt>
                <c:pt idx="14">
                  <c:v>53</c:v>
                </c:pt>
                <c:pt idx="15">
                  <c:v>45</c:v>
                </c:pt>
                <c:pt idx="16">
                  <c:v>55</c:v>
                </c:pt>
                <c:pt idx="17">
                  <c:v>86</c:v>
                </c:pt>
                <c:pt idx="18">
                  <c:v>67</c:v>
                </c:pt>
                <c:pt idx="19">
                  <c:v>83</c:v>
                </c:pt>
                <c:pt idx="20">
                  <c:v>70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cor_Aug14!$A$32:$A$52</c15:f>
                <c15:dlblRangeCache>
                  <c:ptCount val="21"/>
                  <c:pt idx="0">
                    <c:v>Bangladesh</c:v>
                  </c:pt>
                  <c:pt idx="1">
                    <c:v>Bhutan</c:v>
                  </c:pt>
                  <c:pt idx="2">
                    <c:v>Brunei</c:v>
                  </c:pt>
                  <c:pt idx="3">
                    <c:v>Cambodia</c:v>
                  </c:pt>
                  <c:pt idx="4">
                    <c:v>China</c:v>
                  </c:pt>
                  <c:pt idx="5">
                    <c:v>India</c:v>
                  </c:pt>
                  <c:pt idx="6">
                    <c:v>Indonesia</c:v>
                  </c:pt>
                  <c:pt idx="7">
                    <c:v>Iran</c:v>
                  </c:pt>
                  <c:pt idx="8">
                    <c:v>Japan</c:v>
                  </c:pt>
                  <c:pt idx="9">
                    <c:v>Korea, Republic</c:v>
                  </c:pt>
                  <c:pt idx="10">
                    <c:v>Lao PDR</c:v>
                  </c:pt>
                  <c:pt idx="11">
                    <c:v>Malaysia</c:v>
                  </c:pt>
                  <c:pt idx="12">
                    <c:v>Mongolia</c:v>
                  </c:pt>
                  <c:pt idx="13">
                    <c:v>Myanmar</c:v>
                  </c:pt>
                  <c:pt idx="14">
                    <c:v>Nepal</c:v>
                  </c:pt>
                  <c:pt idx="15">
                    <c:v>Pakistan</c:v>
                  </c:pt>
                  <c:pt idx="16">
                    <c:v>Philippines</c:v>
                  </c:pt>
                  <c:pt idx="17">
                    <c:v>Singapore</c:v>
                  </c:pt>
                  <c:pt idx="18">
                    <c:v>Sri Lanka</c:v>
                  </c:pt>
                  <c:pt idx="19">
                    <c:v>Thailand</c:v>
                  </c:pt>
                  <c:pt idx="20">
                    <c:v>Vietnam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7-22AC-4DE8-A436-E77489AD0F7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18817807"/>
        <c:axId val="18822383"/>
      </c:scatterChart>
      <c:valAx>
        <c:axId val="1881780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Age </a:t>
                </a:r>
                <a:r>
                  <a:rPr lang="en-US" sz="1200" b="0" i="0" kern="1200" baseline="0" dirty="0" err="1">
                    <a:solidFill>
                      <a:srgbClr val="595959"/>
                    </a:solidFill>
                    <a:effectLst/>
                  </a:rPr>
                  <a:t>standardised</a:t>
                </a: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 mortality rate of breast cancer per 100,000 female population, GLOBOCAN 2020 estimates</a:t>
                </a:r>
                <a:endParaRPr lang="en-US" sz="12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19679473768184905"/>
              <c:y val="0.939235767500728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22383"/>
        <c:crosses val="autoZero"/>
        <c:crossBetween val="midCat"/>
      </c:valAx>
      <c:valAx>
        <c:axId val="1882238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Universal</a:t>
                </a:r>
                <a:r>
                  <a:rPr lang="en-US" sz="1200" baseline="0" dirty="0"/>
                  <a:t> health coverage </a:t>
                </a:r>
                <a:r>
                  <a:rPr lang="en-US" sz="1200" dirty="0"/>
                  <a:t>index (0-100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1780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r_Aug15!$D$6</c:f>
              <c:strCache>
                <c:ptCount val="1"/>
                <c:pt idx="0">
                  <c:v>% 5-year survival 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fld id="{2C587581-360F-4F21-8587-B2FD683124C7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2473-430A-A472-E5C298483EED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C5DC41DB-8AA9-40F5-A4E7-EA5EC216CEE1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2473-430A-A472-E5C298483EED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11333D2F-C994-4A21-8835-1430C950FA7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2473-430A-A472-E5C298483EED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5AEBD4FB-1332-409E-A1F3-573DF419A06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2473-430A-A472-E5C298483EE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3B711BA6-DA74-4F94-9B4C-FD8E465A9A5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2473-430A-A472-E5C298483EED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123EF23E-A5EA-49BD-9ED5-D1236379B7C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2473-430A-A472-E5C298483EED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6C1DB474-4985-4F6D-8FB9-1E4AF64265D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2473-430A-A472-E5C298483EED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5C817F4B-E6DF-485B-B44B-F401B0D428B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2473-430A-A472-E5C298483EED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1178005D-2A0C-447C-B520-21FC5AEE4F7F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2473-430A-A472-E5C298483EED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93B151BF-70F1-48E1-9BB5-602026DAC4D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2473-430A-A472-E5C298483EED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5D9C7770-47D1-41AF-A3A5-89A9B49CB477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2473-430A-A472-E5C298483EED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CBD63855-50B1-4C5A-B537-BA3D885D2ECD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2473-430A-A472-E5C298483EED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18F4A278-F17A-4305-9AE8-88BCA6A4852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C-2473-430A-A472-E5C298483EED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18356F9E-9C21-4E87-91EB-6F5D59A3772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D-2473-430A-A472-E5C298483EED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85E21C86-C24F-48BF-B0FE-363E62452564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E-2473-430A-A472-E5C298483EE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1.5016335587756568E-2"/>
                  <c:y val="0.3554953662148652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200" baseline="0" dirty="0"/>
                      <a:t>y = -0.5277x + 79.532</a:t>
                    </a:r>
                    <a:br>
                      <a:rPr lang="en-US" sz="1200" baseline="0" dirty="0"/>
                    </a:br>
                    <a:r>
                      <a:rPr lang="en-US" sz="1200" baseline="0" dirty="0"/>
                      <a:t>R² = 0.055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Pearson’s correlation </a:t>
                    </a:r>
                    <a:r>
                      <a:rPr lang="en-US" sz="1200" i="1" dirty="0"/>
                      <a:t>r </a:t>
                    </a:r>
                    <a:r>
                      <a:rPr lang="en-US" sz="1200" dirty="0"/>
                      <a:t>=</a:t>
                    </a:r>
                    <a:r>
                      <a:rPr lang="en-US" sz="1200" baseline="0" dirty="0"/>
                      <a:t> -0.23 (weak</a:t>
                    </a:r>
                    <a:r>
                      <a:rPr lang="en-US" sz="1200" dirty="0"/>
                      <a:t>)</a:t>
                    </a:r>
                  </a:p>
                  <a:p>
                    <a:pPr>
                      <a:defRPr sz="1200"/>
                    </a:pPr>
                    <a:r>
                      <a:rPr lang="en-US" sz="1200" dirty="0"/>
                      <a:t>weighted </a:t>
                    </a:r>
                    <a:r>
                      <a:rPr lang="en-US" sz="1200" i="1" dirty="0"/>
                      <a:t>r </a:t>
                    </a:r>
                    <a:r>
                      <a:rPr lang="en-US" sz="1200" dirty="0"/>
                      <a:t>= -0.60</a:t>
                    </a:r>
                    <a:r>
                      <a:rPr lang="en-US" sz="1200" baseline="0" dirty="0"/>
                      <a:t> </a:t>
                    </a:r>
                    <a:r>
                      <a:rPr lang="en-US" sz="1200" baseline="0"/>
                      <a:t>(strong</a:t>
                    </a:r>
                    <a:r>
                      <a:rPr lang="en-US" sz="1200"/>
                      <a:t>)</a:t>
                    </a:r>
                    <a:endParaRPr lang="en-US" sz="1200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cor_Aug15!$C$7:$C$21</c:f>
              <c:numCache>
                <c:formatCode>General</c:formatCode>
                <c:ptCount val="15"/>
                <c:pt idx="0">
                  <c:v>2.6</c:v>
                </c:pt>
                <c:pt idx="1">
                  <c:v>12.5</c:v>
                </c:pt>
                <c:pt idx="2">
                  <c:v>10</c:v>
                </c:pt>
                <c:pt idx="3">
                  <c:v>13.3</c:v>
                </c:pt>
                <c:pt idx="4">
                  <c:v>15.3</c:v>
                </c:pt>
                <c:pt idx="5">
                  <c:v>10.8</c:v>
                </c:pt>
                <c:pt idx="6">
                  <c:v>9.9</c:v>
                </c:pt>
                <c:pt idx="7">
                  <c:v>6.4</c:v>
                </c:pt>
                <c:pt idx="8">
                  <c:v>20.7</c:v>
                </c:pt>
                <c:pt idx="9">
                  <c:v>3.9</c:v>
                </c:pt>
                <c:pt idx="10">
                  <c:v>19.3</c:v>
                </c:pt>
                <c:pt idx="11">
                  <c:v>17.8</c:v>
                </c:pt>
                <c:pt idx="12">
                  <c:v>11</c:v>
                </c:pt>
                <c:pt idx="13">
                  <c:v>12.7</c:v>
                </c:pt>
                <c:pt idx="14">
                  <c:v>13.8</c:v>
                </c:pt>
              </c:numCache>
            </c:numRef>
          </c:xVal>
          <c:yVal>
            <c:numRef>
              <c:f>cor_Aug15!$D$7:$D$21</c:f>
              <c:numCache>
                <c:formatCode>General</c:formatCode>
                <c:ptCount val="15"/>
                <c:pt idx="0">
                  <c:v>61</c:v>
                </c:pt>
                <c:pt idx="1">
                  <c:v>72</c:v>
                </c:pt>
                <c:pt idx="2">
                  <c:v>82</c:v>
                </c:pt>
                <c:pt idx="3">
                  <c:v>51</c:v>
                </c:pt>
                <c:pt idx="4">
                  <c:v>77.7</c:v>
                </c:pt>
                <c:pt idx="5">
                  <c:v>69.5</c:v>
                </c:pt>
                <c:pt idx="6">
                  <c:v>92.3</c:v>
                </c:pt>
                <c:pt idx="7">
                  <c:v>93.8</c:v>
                </c:pt>
                <c:pt idx="8">
                  <c:v>66.8</c:v>
                </c:pt>
                <c:pt idx="9">
                  <c:v>76.099999999999994</c:v>
                </c:pt>
                <c:pt idx="10">
                  <c:v>59</c:v>
                </c:pt>
                <c:pt idx="11">
                  <c:v>82.4</c:v>
                </c:pt>
                <c:pt idx="12">
                  <c:v>71.599999999999994</c:v>
                </c:pt>
                <c:pt idx="13">
                  <c:v>68.8</c:v>
                </c:pt>
                <c:pt idx="14">
                  <c:v>74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cor_Aug15!$B$7:$B$21</c15:f>
                <c15:dlblRangeCache>
                  <c:ptCount val="15"/>
                  <c:pt idx="0">
                    <c:v>Bhutan</c:v>
                  </c:pt>
                  <c:pt idx="1">
                    <c:v>Brunei</c:v>
                  </c:pt>
                  <c:pt idx="2">
                    <c:v>China</c:v>
                  </c:pt>
                  <c:pt idx="3">
                    <c:v>India</c:v>
                  </c:pt>
                  <c:pt idx="4">
                    <c:v>Indonesia</c:v>
                  </c:pt>
                  <c:pt idx="5">
                    <c:v>Iran</c:v>
                  </c:pt>
                  <c:pt idx="6">
                    <c:v>Japan</c:v>
                  </c:pt>
                  <c:pt idx="7">
                    <c:v>Korea, Republic</c:v>
                  </c:pt>
                  <c:pt idx="8">
                    <c:v>Malaysia</c:v>
                  </c:pt>
                  <c:pt idx="9">
                    <c:v>Mongolia</c:v>
                  </c:pt>
                  <c:pt idx="10">
                    <c:v>Philippines</c:v>
                  </c:pt>
                  <c:pt idx="11">
                    <c:v>Singapore</c:v>
                  </c:pt>
                  <c:pt idx="12">
                    <c:v>Sri Lanka</c:v>
                  </c:pt>
                  <c:pt idx="13">
                    <c:v>Thailand</c:v>
                  </c:pt>
                  <c:pt idx="14">
                    <c:v>Vietnam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1-2473-430A-A472-E5C298483EED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axId val="68638495"/>
        <c:axId val="68646815"/>
      </c:scatterChart>
      <c:valAx>
        <c:axId val="6863849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Age </a:t>
                </a:r>
                <a:r>
                  <a:rPr lang="en-US" sz="1200" b="0" i="0" kern="1200" baseline="0" dirty="0" err="1">
                    <a:solidFill>
                      <a:srgbClr val="595959"/>
                    </a:solidFill>
                    <a:effectLst/>
                  </a:rPr>
                  <a:t>standardised</a:t>
                </a:r>
                <a:r>
                  <a:rPr lang="en-US" sz="1200" b="0" i="0" kern="1200" baseline="0" dirty="0">
                    <a:solidFill>
                      <a:srgbClr val="595959"/>
                    </a:solidFill>
                    <a:effectLst/>
                  </a:rPr>
                  <a:t> mortality rate of breast cancer per 100,000 female population, GLOBOCAN 2020 estimates</a:t>
                </a:r>
                <a:endParaRPr lang="en-US" sz="12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22442916499639951"/>
              <c:y val="0.942275883374105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646815"/>
        <c:crosses val="autoZero"/>
        <c:crossBetween val="midCat"/>
      </c:valAx>
      <c:valAx>
        <c:axId val="686468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Percentage</a:t>
                </a:r>
                <a:r>
                  <a:rPr lang="en-US" sz="1200" baseline="0" dirty="0"/>
                  <a:t> of patients with</a:t>
                </a:r>
                <a:r>
                  <a:rPr lang="en-US" sz="1200" dirty="0"/>
                  <a:t> 5-year survival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63849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EB8EF-ADF9-40DC-8DEB-9CDC85D5AC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69F109-83A4-4BFB-A07C-A790EC37CB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597E9-1C7E-4B58-B6ED-23A514B2C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45DB1-87EC-4E90-886E-44957F044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6E4B3-D041-422F-8C2C-C9CA41C29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499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0EF52-C931-47A1-8D2E-62769BF06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B3341C-24E3-43CF-AD5F-158A596435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FBCEE-E03D-40EC-AF30-408B9EFB1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F7534F-4BCF-41A1-B57D-5E65548D7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3D0E05-46CC-4234-8F19-5A72160D8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96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2CB401-5E7A-47C0-8B0A-612EAD2F2A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6E54D3-0AE7-44E7-9A8C-2D52654E93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F5272-BAAA-4E27-9708-041BC3BB7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F5A810-F638-4D0B-81D0-E1B39617A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BE94C3-8B8C-4CB8-A060-D08EF6C50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5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5F820-17E5-4D35-BDF0-3ED7045761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CA8CCB-16A3-44FE-96DB-09C83E561A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7B02FF-6397-448D-876A-25AD21121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144F6-84F6-46FC-9D0F-AA7111346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386C29-22CF-4C99-8D41-A5F0A7DFB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373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C3079-CB7D-4404-8C44-ED7CF1AFBF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449E5C-1F1B-4FB6-B340-8A5E78A84E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8D5A74-0B21-4A4F-A1C0-630CD9A7C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31399-4D9C-4CF7-ABF1-A7691126E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205D02-34A9-4603-8B5B-5C0E2DED4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349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49D75B-864D-412A-A020-BEED6D11F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4F102A-86E1-4DE4-8B51-354104316E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2819A0-D634-462D-AD96-479933E8DD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846F64-8797-4941-85B8-C7EA9774E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5BBEC5-6126-4C3B-B403-F92392B91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95A6AC-8592-4FE5-9093-6EFE3316D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676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0DCDE-AD2C-487A-ADB2-9EE01397B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49C5DF-9F1F-4F43-9CEE-E0361EC94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AD25BB-B894-433B-BFEE-923C360D46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0ACABD-84B3-43AB-A721-47ACE93689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582013-E645-4144-94FE-05CDFAA00E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C679FE-0616-46BD-AE54-18E313E84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9BC804-D17A-4506-A611-9F4AAA943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627574-A526-4A08-935C-0695375BA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308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EB43C-B965-4085-B976-77D49104F7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A3A2B4-7E7D-4D98-A85F-3737AF20E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B69BF7-B5DD-45C9-B942-AEE7C0B2F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8912A9-52D1-4353-999C-E47E1CF62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125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27B074-BC41-415F-A680-F529D529F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791BE2-3C91-48CC-927F-3F25F8326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54A52-C30F-411A-A6E5-6FFE4E1CC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2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589AC-990B-4A53-ADC5-3220EAD2F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2A12CA-0F36-4DA4-A7F0-563F57E75B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85C7A4-70E1-4917-9EC5-8415EB3BCA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E6542E-CB90-4643-8DCE-C14A41E5F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F794D2-4F2D-4ED9-AB91-21C448989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F4635F-F581-4559-A321-16AD14930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214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89DD6-2589-4BE0-8AD8-B37F275B58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3DF762-C099-4DDA-A164-EA04FF585A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0E3AFA-B885-42C8-8BDC-2C0F1C3545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206110-C664-404D-B5BF-420E53A7E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5A9E5A-F6C2-4AF0-B546-62B2E0CF1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486B66-8FA7-4D84-B43A-AED5C8912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41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882FAD-B322-4A48-AFCD-ED369441B0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C6FD32-8EEB-492E-B415-BF1F0DC889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EFAD6B-C3DC-4CD4-881A-A43720C410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19B41-1E51-411D-9FB9-AEB006303B74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0A543F-6401-4B74-A8FB-D6399C1FFF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EC5DF-F54D-4217-9868-28D1C6CAFA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CA52B-E15C-4C45-A5E8-74F2FEBA0F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735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556181" y="188535"/>
            <a:ext cx="10863607" cy="268665"/>
          </a:xfrm>
          <a:prstGeom prst="rect">
            <a:avLst/>
          </a:prstGeom>
        </p:spPr>
        <p:txBody>
          <a:bodyPr>
            <a:normAutofit fontScale="925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a: Correlation between proportion of patients diagnosed in Stage I and II (Pillar 1 KPI) and age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ise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rtality rate from local registry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0107700"/>
              </p:ext>
            </p:extLst>
          </p:nvPr>
        </p:nvGraphicFramePr>
        <p:xfrm>
          <a:off x="1414021" y="457200"/>
          <a:ext cx="9297798" cy="6066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848410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904188" y="188535"/>
            <a:ext cx="10515600" cy="282805"/>
          </a:xfrm>
          <a:prstGeom prst="rect">
            <a:avLst/>
          </a:prstGeom>
        </p:spPr>
        <p:txBody>
          <a:bodyPr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b: Correlation between proportion of patients diagnosed in Stage I and II (Pillar 1 KPI) and ASMR from GLOBOCAN estimates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4897448"/>
              </p:ext>
            </p:extLst>
          </p:nvPr>
        </p:nvGraphicFramePr>
        <p:xfrm>
          <a:off x="1786890" y="457200"/>
          <a:ext cx="8618220" cy="59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858720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904188" y="188535"/>
            <a:ext cx="10515600" cy="282805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a: Correlation between 5-year survival rate and age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ise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rtality rate from local registr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568779"/>
              </p:ext>
            </p:extLst>
          </p:nvPr>
        </p:nvGraphicFramePr>
        <p:xfrm>
          <a:off x="904188" y="640827"/>
          <a:ext cx="9772173" cy="6028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17772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904187" y="188535"/>
            <a:ext cx="10785049" cy="33465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b: Correlation between Universal Health Coverage index and age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ise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rtality rate from local registry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300-000005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814412"/>
              </p:ext>
            </p:extLst>
          </p:nvPr>
        </p:nvGraphicFramePr>
        <p:xfrm>
          <a:off x="827483" y="782426"/>
          <a:ext cx="10067011" cy="55523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185308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938637" y="150828"/>
            <a:ext cx="10515600" cy="282805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c: Correlation between Universal Health Coverage index and estimated ASMR from 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GLOBOCAN  2020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0000000-0008-0000-0300-000004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6450504"/>
              </p:ext>
            </p:extLst>
          </p:nvPr>
        </p:nvGraphicFramePr>
        <p:xfrm>
          <a:off x="938637" y="791853"/>
          <a:ext cx="9946643" cy="5476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33467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C8B866F5-048C-4F56-A0F4-C750006FC138}"/>
              </a:ext>
            </a:extLst>
          </p:cNvPr>
          <p:cNvSpPr txBox="1">
            <a:spLocks/>
          </p:cNvSpPr>
          <p:nvPr/>
        </p:nvSpPr>
        <p:spPr>
          <a:xfrm>
            <a:off x="904188" y="188535"/>
            <a:ext cx="10515600" cy="282805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d: Correlation between 5-year survival rate and estimated age-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ardise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rtality rate from GLOBOCAN 2020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1043313"/>
              </p:ext>
            </p:extLst>
          </p:nvPr>
        </p:nvGraphicFramePr>
        <p:xfrm>
          <a:off x="904188" y="752475"/>
          <a:ext cx="9334834" cy="6030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6609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261</Words>
  <Application>Microsoft Office PowerPoint</Application>
  <PresentationFormat>Widescreen</PresentationFormat>
  <Paragraphs>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Ong Sok King</dc:creator>
  <cp:lastModifiedBy>Dr Ong Sok King</cp:lastModifiedBy>
  <cp:revision>42</cp:revision>
  <dcterms:created xsi:type="dcterms:W3CDTF">2023-05-19T07:01:29Z</dcterms:created>
  <dcterms:modified xsi:type="dcterms:W3CDTF">2023-11-21T09:15:50Z</dcterms:modified>
</cp:coreProperties>
</file>